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697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2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052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712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925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7654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039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477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9931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894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1493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25B90-CE46-4B0F-B133-C3E84B25BA1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BBA1E-9CE6-43A0-B95F-B5DC3A5A33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0726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1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6.tiff"/><Relationship Id="rId7" Type="http://schemas.openxmlformats.org/officeDocument/2006/relationships/image" Target="../media/image20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5" Type="http://schemas.openxmlformats.org/officeDocument/2006/relationships/image" Target="../media/image18.png"/><Relationship Id="rId4" Type="http://schemas.openxmlformats.org/officeDocument/2006/relationships/image" Target="../media/image17.tiff"/><Relationship Id="rId9" Type="http://schemas.openxmlformats.org/officeDocument/2006/relationships/image" Target="../media/image2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660323" y="327180"/>
            <a:ext cx="12302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2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7122" r="13068" b="16515"/>
          <a:stretch/>
        </p:blipFill>
        <p:spPr bwMode="auto">
          <a:xfrm>
            <a:off x="6898458" y="4572000"/>
            <a:ext cx="2318243" cy="19905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3" t="6960" r="12667" b="16821"/>
          <a:stretch/>
        </p:blipFill>
        <p:spPr bwMode="auto">
          <a:xfrm>
            <a:off x="4547215" y="4572000"/>
            <a:ext cx="2334743" cy="1986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7" t="6323" r="12860" b="16758"/>
          <a:stretch/>
        </p:blipFill>
        <p:spPr bwMode="auto">
          <a:xfrm>
            <a:off x="2220722" y="4557486"/>
            <a:ext cx="2326493" cy="2005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4811111" y="4211775"/>
            <a:ext cx="182681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+Ad-MOCK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534622" y="1315579"/>
            <a:ext cx="198401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3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Ad-MOCK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458643" y="4225343"/>
            <a:ext cx="1434511" cy="265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+Ad-VT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981719" y="1352344"/>
            <a:ext cx="1911435" cy="265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3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Ad-VT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741232" y="1316017"/>
            <a:ext cx="1294854" cy="265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864463" y="4177260"/>
            <a:ext cx="1294854" cy="265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84824" y="1646646"/>
            <a:ext cx="2231329" cy="2085013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34622" y="1646646"/>
            <a:ext cx="2225233" cy="207282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41914" y="1664605"/>
            <a:ext cx="2231329" cy="2078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19070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1111" y="274642"/>
            <a:ext cx="9150889" cy="192650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1111" y="2480069"/>
            <a:ext cx="9150889" cy="1926503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1111" y="4776829"/>
            <a:ext cx="9150889" cy="1926503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645" y="165722"/>
            <a:ext cx="2225233" cy="2091109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9011" y="2480069"/>
            <a:ext cx="2225233" cy="207282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010" y="4673727"/>
            <a:ext cx="2225233" cy="2078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7568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6662" r="13068" b="16516"/>
          <a:stretch/>
        </p:blipFill>
        <p:spPr bwMode="auto">
          <a:xfrm>
            <a:off x="16500" y="4857750"/>
            <a:ext cx="2318243" cy="20025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3" t="6960" r="12667" b="16821"/>
          <a:stretch/>
        </p:blipFill>
        <p:spPr bwMode="auto">
          <a:xfrm>
            <a:off x="0" y="2743200"/>
            <a:ext cx="2334743" cy="1986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7" t="7245" r="12860" b="16758"/>
          <a:stretch/>
        </p:blipFill>
        <p:spPr bwMode="auto">
          <a:xfrm>
            <a:off x="0" y="352425"/>
            <a:ext cx="2326493" cy="1981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70200" y="446768"/>
            <a:ext cx="9150889" cy="179237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70200" y="2677739"/>
            <a:ext cx="9150889" cy="1792379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70199" y="4962843"/>
            <a:ext cx="9150889" cy="1792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15739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254997" y="2709186"/>
            <a:ext cx="2365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Ad-V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4445" y="428369"/>
            <a:ext cx="4875030" cy="162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4445" y="5361446"/>
            <a:ext cx="4875030" cy="162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4445" y="2072728"/>
            <a:ext cx="4875030" cy="162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4445" y="3717087"/>
            <a:ext cx="4875030" cy="162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7850401" y="122013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RP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9473879" y="120591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11146498" y="120592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6458310" y="1077430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AD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719220" y="4391530"/>
            <a:ext cx="19029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ADR+3-M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737000" y="6045317"/>
            <a:ext cx="19029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ADR+CQ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78118" y="0"/>
            <a:ext cx="11113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fig2G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602" y="3910921"/>
            <a:ext cx="3249491" cy="108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602" y="5019891"/>
            <a:ext cx="3249492" cy="108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602" y="2804790"/>
            <a:ext cx="3249492" cy="1080000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1833787" y="1385207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-GFP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2872262" y="1385207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3977771" y="1385207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xmlns="" id="{66B28FFC-3E4B-4689-B2BD-D8EBBF84FAC2}"/>
              </a:ext>
            </a:extLst>
          </p:cNvPr>
          <p:cNvSpPr txBox="1"/>
          <p:nvPr/>
        </p:nvSpPr>
        <p:spPr>
          <a:xfrm>
            <a:off x="657626" y="2117206"/>
            <a:ext cx="1176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40230" y="4297033"/>
            <a:ext cx="13933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AD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89947" y="3208176"/>
            <a:ext cx="1543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+Ad-V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-223263" y="5378756"/>
            <a:ext cx="20568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R+Ad-V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36547" y="615765"/>
            <a:ext cx="14567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fig2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602" y="1689722"/>
            <a:ext cx="3250800" cy="1080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3108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宽屏</PresentationFormat>
  <Paragraphs>2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905381255@qq.com</dc:creator>
  <cp:lastModifiedBy>905381255@qq.com</cp:lastModifiedBy>
  <cp:revision>2</cp:revision>
  <dcterms:created xsi:type="dcterms:W3CDTF">2021-08-25T13:39:39Z</dcterms:created>
  <dcterms:modified xsi:type="dcterms:W3CDTF">2021-08-25T13:42:25Z</dcterms:modified>
</cp:coreProperties>
</file>